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792913" cy="992505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北村峰昭" initials="北村峰昭" lastIdx="1" clrIdx="0">
    <p:extLst>
      <p:ext uri="{19B8F6BF-5375-455C-9EA6-DF929625EA0E}">
        <p15:presenceInfo xmlns:p15="http://schemas.microsoft.com/office/powerpoint/2012/main" userId="b9aa565d2bbd325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6429" autoAdjust="0"/>
  </p:normalViewPr>
  <p:slideViewPr>
    <p:cSldViewPr snapToGrid="0">
      <p:cViewPr varScale="1">
        <p:scale>
          <a:sx n="110" d="100"/>
          <a:sy n="110" d="100"/>
        </p:scale>
        <p:origin x="139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805381-C0C1-4D78-9A27-F0C3FE716FE6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3638" y="1241425"/>
            <a:ext cx="4465637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4013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810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768EED-D0B8-4CED-8889-6F5100710D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62550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768EED-D0B8-4CED-8889-6F5100710D5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99441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7844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699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3466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0944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0961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23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9295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25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1024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084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377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4DA5C8-56A1-4709-80F2-0E047D0A2822}" type="datetimeFigureOut">
              <a:rPr kumimoji="1" lang="ja-JP" altLang="en-US" smtClean="0"/>
              <a:t>2021/9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A620B-259A-4CC6-B622-E0B0A9EEFC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359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テキスト ボックス 31"/>
          <p:cNvSpPr txBox="1"/>
          <p:nvPr/>
        </p:nvSpPr>
        <p:spPr>
          <a:xfrm>
            <a:off x="90201" y="620629"/>
            <a:ext cx="135005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% PMI change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239949" y="6457148"/>
            <a:ext cx="118974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S 0(1 year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2580215" y="6457148"/>
            <a:ext cx="118974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S 1(1 year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971469" y="6457148"/>
            <a:ext cx="118974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S 2(1 year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315399" y="6457148"/>
            <a:ext cx="114005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S 3(I year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6655665" y="6457148"/>
            <a:ext cx="118974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S 4(1 year)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67E4B116-67EE-4D2D-9DD0-4909B67121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70" t="3699" r="7440" b="4435"/>
          <a:stretch/>
        </p:blipFill>
        <p:spPr>
          <a:xfrm>
            <a:off x="1032946" y="1044714"/>
            <a:ext cx="6917972" cy="5384195"/>
          </a:xfrm>
          <a:prstGeom prst="rect">
            <a:avLst/>
          </a:prstGeom>
        </p:spPr>
      </p:pic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3D54D187-4094-44FB-9B5B-07DD9243C32C}"/>
              </a:ext>
            </a:extLst>
          </p:cNvPr>
          <p:cNvSpPr txBox="1"/>
          <p:nvPr/>
        </p:nvSpPr>
        <p:spPr>
          <a:xfrm>
            <a:off x="680005" y="882299"/>
            <a:ext cx="38343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5CF7EC3A-084E-46F1-AD4B-75A8D340CE1D}"/>
              </a:ext>
            </a:extLst>
          </p:cNvPr>
          <p:cNvSpPr txBox="1"/>
          <p:nvPr/>
        </p:nvSpPr>
        <p:spPr>
          <a:xfrm>
            <a:off x="680005" y="1392514"/>
            <a:ext cx="38343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9787C662-54BC-4585-B1AD-0A20B15199FE}"/>
              </a:ext>
            </a:extLst>
          </p:cNvPr>
          <p:cNvSpPr txBox="1"/>
          <p:nvPr/>
        </p:nvSpPr>
        <p:spPr>
          <a:xfrm>
            <a:off x="680005" y="1902729"/>
            <a:ext cx="38343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25ACDEC-A99E-47FB-85E4-C7FEC184D109}"/>
              </a:ext>
            </a:extLst>
          </p:cNvPr>
          <p:cNvSpPr txBox="1"/>
          <p:nvPr/>
        </p:nvSpPr>
        <p:spPr>
          <a:xfrm>
            <a:off x="779391" y="2412944"/>
            <a:ext cx="28405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8EA586A-7FC4-4795-9B26-3115D510A494}"/>
              </a:ext>
            </a:extLst>
          </p:cNvPr>
          <p:cNvSpPr txBox="1"/>
          <p:nvPr/>
        </p:nvSpPr>
        <p:spPr>
          <a:xfrm>
            <a:off x="620693" y="2923159"/>
            <a:ext cx="44275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E74BE335-DC8A-49AB-ABA9-7747BF356741}"/>
              </a:ext>
            </a:extLst>
          </p:cNvPr>
          <p:cNvSpPr txBox="1"/>
          <p:nvPr/>
        </p:nvSpPr>
        <p:spPr>
          <a:xfrm>
            <a:off x="620693" y="3433374"/>
            <a:ext cx="44275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D261819-0D62-4EB8-AB0A-2077D46AFEAD}"/>
              </a:ext>
            </a:extLst>
          </p:cNvPr>
          <p:cNvSpPr txBox="1"/>
          <p:nvPr/>
        </p:nvSpPr>
        <p:spPr>
          <a:xfrm>
            <a:off x="620693" y="3943589"/>
            <a:ext cx="44275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3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4C91773-3595-40CD-A3A5-A2625895AF51}"/>
              </a:ext>
            </a:extLst>
          </p:cNvPr>
          <p:cNvSpPr txBox="1"/>
          <p:nvPr/>
        </p:nvSpPr>
        <p:spPr>
          <a:xfrm>
            <a:off x="620693" y="4453804"/>
            <a:ext cx="44275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98E8E99-1DE2-4A35-8276-31C380FACB49}"/>
              </a:ext>
            </a:extLst>
          </p:cNvPr>
          <p:cNvSpPr txBox="1"/>
          <p:nvPr/>
        </p:nvSpPr>
        <p:spPr>
          <a:xfrm>
            <a:off x="620693" y="4964020"/>
            <a:ext cx="44275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F69EE588-8111-4B89-A495-E19236F7184E}"/>
              </a:ext>
            </a:extLst>
          </p:cNvPr>
          <p:cNvSpPr txBox="1"/>
          <p:nvPr/>
        </p:nvSpPr>
        <p:spPr>
          <a:xfrm>
            <a:off x="620693" y="5474235"/>
            <a:ext cx="44275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6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A9EA4ED-CE59-4E74-A7C7-4B2F2D7A7C7D}"/>
              </a:ext>
            </a:extLst>
          </p:cNvPr>
          <p:cNvSpPr txBox="1"/>
          <p:nvPr/>
        </p:nvSpPr>
        <p:spPr>
          <a:xfrm>
            <a:off x="620693" y="5984454"/>
            <a:ext cx="44275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-70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549868E7-B67F-43F6-BEFC-222FDC98EE46}"/>
              </a:ext>
            </a:extLst>
          </p:cNvPr>
          <p:cNvSpPr txBox="1"/>
          <p:nvPr/>
        </p:nvSpPr>
        <p:spPr>
          <a:xfrm>
            <a:off x="3226424" y="963995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* p=0.005</a:t>
            </a:r>
            <a:endParaRPr kumimoji="1" lang="ja-JP" altLang="en-US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5C3592F-361F-4569-B2FC-689D963DF28C}"/>
              </a:ext>
            </a:extLst>
          </p:cNvPr>
          <p:cNvSpPr txBox="1"/>
          <p:nvPr/>
        </p:nvSpPr>
        <p:spPr>
          <a:xfrm>
            <a:off x="6210798" y="729477"/>
            <a:ext cx="1178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**p&lt;0.001</a:t>
            </a:r>
            <a:endParaRPr kumimoji="1" lang="ja-JP" altLang="en-US" dirty="0"/>
          </a:p>
        </p:txBody>
      </p:sp>
      <p:grpSp>
        <p:nvGrpSpPr>
          <p:cNvPr id="61" name="グループ化 60">
            <a:extLst>
              <a:ext uri="{FF2B5EF4-FFF2-40B4-BE49-F238E27FC236}">
                <a16:creationId xmlns:a16="http://schemas.microsoft.com/office/drawing/2014/main" id="{13EB9273-691E-48DA-94FD-F9A124881FB5}"/>
              </a:ext>
            </a:extLst>
          </p:cNvPr>
          <p:cNvGrpSpPr/>
          <p:nvPr/>
        </p:nvGrpSpPr>
        <p:grpSpPr>
          <a:xfrm>
            <a:off x="1770354" y="987271"/>
            <a:ext cx="2787045" cy="157609"/>
            <a:chOff x="1820256" y="243555"/>
            <a:chExt cx="2622134" cy="183735"/>
          </a:xfrm>
        </p:grpSpPr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0A1BB87B-B7AB-4B6B-96B4-354EB5C904F5}"/>
                </a:ext>
              </a:extLst>
            </p:cNvPr>
            <p:cNvCxnSpPr/>
            <p:nvPr/>
          </p:nvCxnSpPr>
          <p:spPr>
            <a:xfrm>
              <a:off x="1820256" y="243555"/>
              <a:ext cx="2622134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363472FB-61C6-46F9-A16B-95302DE87117}"/>
                </a:ext>
              </a:extLst>
            </p:cNvPr>
            <p:cNvCxnSpPr/>
            <p:nvPr/>
          </p:nvCxnSpPr>
          <p:spPr>
            <a:xfrm>
              <a:off x="1820256" y="243555"/>
              <a:ext cx="0" cy="18373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92C1FA92-7F57-4D81-9C2A-1078AEDBD8A2}"/>
                </a:ext>
              </a:extLst>
            </p:cNvPr>
            <p:cNvCxnSpPr/>
            <p:nvPr/>
          </p:nvCxnSpPr>
          <p:spPr>
            <a:xfrm>
              <a:off x="4440967" y="243555"/>
              <a:ext cx="0" cy="18373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939A1F28-746C-40B5-A60E-98FA9F67884E}"/>
              </a:ext>
            </a:extLst>
          </p:cNvPr>
          <p:cNvGrpSpPr/>
          <p:nvPr/>
        </p:nvGrpSpPr>
        <p:grpSpPr>
          <a:xfrm>
            <a:off x="1769630" y="755604"/>
            <a:ext cx="5545562" cy="341832"/>
            <a:chOff x="1820256" y="243555"/>
            <a:chExt cx="2622134" cy="183735"/>
          </a:xfrm>
        </p:grpSpPr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3F813004-C38C-4864-9267-3D871662FFB7}"/>
                </a:ext>
              </a:extLst>
            </p:cNvPr>
            <p:cNvCxnSpPr/>
            <p:nvPr/>
          </p:nvCxnSpPr>
          <p:spPr>
            <a:xfrm>
              <a:off x="1820256" y="243555"/>
              <a:ext cx="2622134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9E7FEF6A-8F70-4022-869C-F1145F3360B7}"/>
                </a:ext>
              </a:extLst>
            </p:cNvPr>
            <p:cNvCxnSpPr/>
            <p:nvPr/>
          </p:nvCxnSpPr>
          <p:spPr>
            <a:xfrm>
              <a:off x="1820256" y="243555"/>
              <a:ext cx="0" cy="18373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08FABA6C-60E4-403D-B1A8-D97C7CC08977}"/>
                </a:ext>
              </a:extLst>
            </p:cNvPr>
            <p:cNvCxnSpPr/>
            <p:nvPr/>
          </p:nvCxnSpPr>
          <p:spPr>
            <a:xfrm>
              <a:off x="4440967" y="243555"/>
              <a:ext cx="0" cy="18373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7F78B3C3-D24E-411D-ACF2-6D4B22809737}"/>
              </a:ext>
            </a:extLst>
          </p:cNvPr>
          <p:cNvGrpSpPr/>
          <p:nvPr/>
        </p:nvGrpSpPr>
        <p:grpSpPr>
          <a:xfrm>
            <a:off x="1765997" y="884486"/>
            <a:ext cx="4190652" cy="177660"/>
            <a:chOff x="1820256" y="243555"/>
            <a:chExt cx="2622134" cy="183735"/>
          </a:xfrm>
        </p:grpSpPr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FF97A287-F813-46F5-9B70-1BBB42E5EB75}"/>
                </a:ext>
              </a:extLst>
            </p:cNvPr>
            <p:cNvCxnSpPr/>
            <p:nvPr/>
          </p:nvCxnSpPr>
          <p:spPr>
            <a:xfrm>
              <a:off x="1820256" y="243555"/>
              <a:ext cx="2622134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9328C7F3-EC2C-4F41-90BD-BA212A08CEEF}"/>
                </a:ext>
              </a:extLst>
            </p:cNvPr>
            <p:cNvCxnSpPr/>
            <p:nvPr/>
          </p:nvCxnSpPr>
          <p:spPr>
            <a:xfrm>
              <a:off x="1820256" y="243555"/>
              <a:ext cx="0" cy="18373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id="{2E52980E-8313-4377-A80B-5D8AA13F574E}"/>
                </a:ext>
              </a:extLst>
            </p:cNvPr>
            <p:cNvCxnSpPr/>
            <p:nvPr/>
          </p:nvCxnSpPr>
          <p:spPr>
            <a:xfrm>
              <a:off x="4440967" y="243555"/>
              <a:ext cx="0" cy="18373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3459BB30-8074-4B98-ADAB-EE46C94A6336}"/>
              </a:ext>
            </a:extLst>
          </p:cNvPr>
          <p:cNvSpPr txBox="1"/>
          <p:nvPr/>
        </p:nvSpPr>
        <p:spPr>
          <a:xfrm>
            <a:off x="4561038" y="830844"/>
            <a:ext cx="13956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**p&lt;0.001</a:t>
            </a:r>
            <a:endParaRPr kumimoji="1" lang="ja-JP" altLang="en-US" dirty="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C3FCBB9D-0F40-463C-93AF-B61FFAC1F725}"/>
              </a:ext>
            </a:extLst>
          </p:cNvPr>
          <p:cNvSpPr txBox="1"/>
          <p:nvPr/>
        </p:nvSpPr>
        <p:spPr>
          <a:xfrm>
            <a:off x="1239950" y="46077"/>
            <a:ext cx="76515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he association between % change of psoas muscle (%PMI) and Eastern Cooperative Oncology Group Performance Status Scale (PS) after one year 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33B336FA-1BDD-4E2F-A91A-46CFB08A73CA}"/>
              </a:ext>
            </a:extLst>
          </p:cNvPr>
          <p:cNvSpPr txBox="1"/>
          <p:nvPr/>
        </p:nvSpPr>
        <p:spPr>
          <a:xfrm>
            <a:off x="7798719" y="6299938"/>
            <a:ext cx="13888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</a:p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4395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2</TotalTime>
  <Words>84</Words>
  <Application>Microsoft Office PowerPoint</Application>
  <PresentationFormat>画面に合わせる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北村峰昭</dc:creator>
  <cp:lastModifiedBy>北村 峰昭</cp:lastModifiedBy>
  <cp:revision>31</cp:revision>
  <dcterms:created xsi:type="dcterms:W3CDTF">2021-07-04T00:25:33Z</dcterms:created>
  <dcterms:modified xsi:type="dcterms:W3CDTF">2021-09-03T02:25:21Z</dcterms:modified>
</cp:coreProperties>
</file>